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napVertSplitter="1" vertBarState="minimized">
    <p:restoredLeft sz="15620"/>
    <p:restoredTop sz="94660"/>
  </p:normalViewPr>
  <p:slideViewPr>
    <p:cSldViewPr>
      <p:cViewPr>
        <p:scale>
          <a:sx n="100" d="100"/>
          <a:sy n="100" d="100"/>
        </p:scale>
        <p:origin x="-1752" y="-666"/>
      </p:cViewPr>
      <p:guideLst>
        <p:guide orient="horz" pos="351"/>
        <p:guide pos="33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E7D44-6BA6-419B-8E00-5F48EBE86C7D}" type="datetimeFigureOut">
              <a:rPr lang="en-CA" smtClean="0"/>
              <a:t>08/07/202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731E5-85AC-486D-83EE-2DED90BC736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217431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E7D44-6BA6-419B-8E00-5F48EBE86C7D}" type="datetimeFigureOut">
              <a:rPr lang="en-CA" smtClean="0"/>
              <a:t>08/07/202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731E5-85AC-486D-83EE-2DED90BC736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203123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E7D44-6BA6-419B-8E00-5F48EBE86C7D}" type="datetimeFigureOut">
              <a:rPr lang="en-CA" smtClean="0"/>
              <a:t>08/07/202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731E5-85AC-486D-83EE-2DED90BC736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068054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E7D44-6BA6-419B-8E00-5F48EBE86C7D}" type="datetimeFigureOut">
              <a:rPr lang="en-CA" smtClean="0"/>
              <a:t>08/07/202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731E5-85AC-486D-83EE-2DED90BC736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063683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E7D44-6BA6-419B-8E00-5F48EBE86C7D}" type="datetimeFigureOut">
              <a:rPr lang="en-CA" smtClean="0"/>
              <a:t>08/07/202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731E5-85AC-486D-83EE-2DED90BC736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111149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E7D44-6BA6-419B-8E00-5F48EBE86C7D}" type="datetimeFigureOut">
              <a:rPr lang="en-CA" smtClean="0"/>
              <a:t>08/07/202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731E5-85AC-486D-83EE-2DED90BC736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26005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E7D44-6BA6-419B-8E00-5F48EBE86C7D}" type="datetimeFigureOut">
              <a:rPr lang="en-CA" smtClean="0"/>
              <a:t>08/07/2022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731E5-85AC-486D-83EE-2DED90BC736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012759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E7D44-6BA6-419B-8E00-5F48EBE86C7D}" type="datetimeFigureOut">
              <a:rPr lang="en-CA" smtClean="0"/>
              <a:t>08/07/2022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731E5-85AC-486D-83EE-2DED90BC736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470971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E7D44-6BA6-419B-8E00-5F48EBE86C7D}" type="datetimeFigureOut">
              <a:rPr lang="en-CA" smtClean="0"/>
              <a:t>08/07/2022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731E5-85AC-486D-83EE-2DED90BC736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35110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E7D44-6BA6-419B-8E00-5F48EBE86C7D}" type="datetimeFigureOut">
              <a:rPr lang="en-CA" smtClean="0"/>
              <a:t>08/07/202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731E5-85AC-486D-83EE-2DED90BC736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263275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E7D44-6BA6-419B-8E00-5F48EBE86C7D}" type="datetimeFigureOut">
              <a:rPr lang="en-CA" smtClean="0"/>
              <a:t>08/07/202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731E5-85AC-486D-83EE-2DED90BC736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306366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BE7D44-6BA6-419B-8E00-5F48EBE86C7D}" type="datetimeFigureOut">
              <a:rPr lang="en-CA" smtClean="0"/>
              <a:t>08/07/202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A731E5-85AC-486D-83EE-2DED90BC736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924417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599554" y="413197"/>
            <a:ext cx="3882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)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591425" y="3275692"/>
            <a:ext cx="3802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  <a:r>
              <a:rPr lang="en-US" dirty="0" smtClean="0"/>
              <a:t>)</a:t>
            </a:r>
            <a:endParaRPr lang="en-US" dirty="0"/>
          </a:p>
        </p:txBody>
      </p:sp>
      <p:pic>
        <p:nvPicPr>
          <p:cNvPr id="7" name="Picture 6" descr="CD4, CD8 differences in trajectories.tiff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6056" y="260648"/>
            <a:ext cx="5410200" cy="2908300"/>
          </a:xfrm>
          <a:prstGeom prst="rect">
            <a:avLst/>
          </a:prstGeom>
        </p:spPr>
      </p:pic>
      <p:pic>
        <p:nvPicPr>
          <p:cNvPr id="8" name="Picture 7" descr="CD4-CD8 difference in slopes.tiff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0032" y="3129632"/>
            <a:ext cx="5422900" cy="23876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467545" y="5445224"/>
            <a:ext cx="842493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/>
                <a:cs typeface="Times New Roman"/>
              </a:rPr>
              <a:t>SUPPLEMENTAL FIGURE 5</a:t>
            </a:r>
            <a:r>
              <a:rPr lang="en-US" sz="1200" dirty="0" smtClean="0">
                <a:latin typeface="Times New Roman"/>
                <a:cs typeface="Times New Roman"/>
              </a:rPr>
              <a:t>  CD4 T lymphocyte count, CD8 T lymphocyte count (A) and CD4:CD8 ratios (B) analyzed using linear mixed-effects model analysis were not significantly different between Control and Treatment groups. The mean slope for CD4, CD8 and the CD4:CD8 ratio were calculated for Control and Treatment groups (all data was censored for those off-protocol (OP)). A) The difference in the mean slopes for Control versus Treatment are presented for CD4 and CD8 T lymphocytes over 52 </a:t>
            </a:r>
            <a:r>
              <a:rPr lang="en-US" sz="1200" dirty="0">
                <a:latin typeface="Times New Roman"/>
                <a:cs typeface="Times New Roman"/>
              </a:rPr>
              <a:t>weeks with 95% confidence interval (capped bars) and p value. </a:t>
            </a:r>
            <a:r>
              <a:rPr lang="en-US" sz="1200" dirty="0" smtClean="0">
                <a:latin typeface="Times New Roman"/>
                <a:cs typeface="Times New Roman"/>
              </a:rPr>
              <a:t>B) The difference in the mean slopes for the CD4:CD8 ratio over 52 weeks is reported with 95% confidence interval (capped bars) and p value. </a:t>
            </a:r>
            <a:endParaRPr lang="en-US" sz="12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5117912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222</TotalTime>
  <Words>136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llick, Ranjeeta</dc:creator>
  <cp:lastModifiedBy>Satya Veni Pabbu</cp:lastModifiedBy>
  <cp:revision>128</cp:revision>
  <dcterms:created xsi:type="dcterms:W3CDTF">2017-09-06T23:52:20Z</dcterms:created>
  <dcterms:modified xsi:type="dcterms:W3CDTF">2022-07-08T01:43:51Z</dcterms:modified>
</cp:coreProperties>
</file>